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EAF2F3"/>
    <a:srgbClr val="DCEAF7"/>
    <a:srgbClr val="E7EAED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661" autoAdjust="0"/>
    <p:restoredTop sz="94126" autoAdjust="0"/>
  </p:normalViewPr>
  <p:slideViewPr>
    <p:cSldViewPr snapToGrid="0">
      <p:cViewPr varScale="1">
        <p:scale>
          <a:sx n="111" d="100"/>
          <a:sy n="111" d="100"/>
        </p:scale>
        <p:origin x="1008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9789E51-78FB-4FFA-8FD9-885652A78DD5}" type="datetimeFigureOut">
              <a:rPr lang="en-US" smtClean="0"/>
              <a:t>1/27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4B006D-0BC0-4B3E-A7E4-E63E10287F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6567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74B006D-0BC0-4B3E-A7E4-E63E10287F6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47252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3B694E-1E80-4DD4-1430-2EAF1408465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6FD0F24-86C3-919B-64E8-30BDE659BD6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39FB38-6ADB-8689-6656-395E64BB30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D68523-EE51-4EEB-BD16-FCB29625D885}" type="datetimeFigureOut">
              <a:rPr lang="en-US" smtClean="0"/>
              <a:t>1/27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E86AAB-8DC0-4292-188F-E21E4140FE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7FF4E8-D2EC-D4C3-B84A-38F9150E9F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476F3-C897-446C-ACAC-3F861136C1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20403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AA2DB4-2016-042C-74C7-A73D0BC35E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6945185-37AB-BE66-0804-D5CD1EDFF46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2EADEA-423E-C899-A800-829895B54A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D68523-EE51-4EEB-BD16-FCB29625D885}" type="datetimeFigureOut">
              <a:rPr lang="en-US" smtClean="0"/>
              <a:t>1/27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371576-A8F3-A53F-B1E9-B4FB592716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585396-061C-DCF1-5337-E1CABF4812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476F3-C897-446C-ACAC-3F861136C1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43456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264821C-2DB1-7112-7F5D-DF2DD126FF1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BD8BC3A-49AE-3D07-0022-21CC274E24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989443-6279-F18B-C127-A76321CFDB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D68523-EE51-4EEB-BD16-FCB29625D885}" type="datetimeFigureOut">
              <a:rPr lang="en-US" smtClean="0"/>
              <a:t>1/27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E35B40-8E8D-B66A-3778-E18D622631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0B343B-1FF4-ED7A-429D-CFDEF1AAE5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476F3-C897-446C-ACAC-3F861136C1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31483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2DE999-A62C-8010-D023-3F07794A81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891E696-DF5F-9962-2267-36B0B70283A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54EE57-5A0B-F62A-C622-D9880C8604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D68523-EE51-4EEB-BD16-FCB29625D885}" type="datetimeFigureOut">
              <a:rPr lang="en-US" smtClean="0"/>
              <a:t>1/27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861E40-7E9D-E501-2A3E-8CBB5344D9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2612F8-FB26-A318-BB35-34EC84D688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476F3-C897-446C-ACAC-3F861136C1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77159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5D36CA-B5B5-C672-EA57-86E440C384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1970068-BB9D-09DD-D2DB-D7D05028AA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68CA31-BFCC-6942-7F39-3247CFEC42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D68523-EE51-4EEB-BD16-FCB29625D885}" type="datetimeFigureOut">
              <a:rPr lang="en-US" smtClean="0"/>
              <a:t>1/27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C23977-0AC3-98A1-828A-A1AB4CDCD3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DF3AAF-6EF6-0F17-C827-31ED7BBF0E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476F3-C897-446C-ACAC-3F861136C1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59324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69B755-BF6A-89CA-F651-0E62CDF164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8959C04-80F3-07E8-C68D-77ACFA87EB6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5CD413F-4274-0CB0-4AD4-1E3EFDACAB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71F4155-EB18-2A1E-C163-6F0A0EDE07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D68523-EE51-4EEB-BD16-FCB29625D885}" type="datetimeFigureOut">
              <a:rPr lang="en-US" smtClean="0"/>
              <a:t>1/27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3B77FD4-297B-1E8D-E504-167B712DEE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2188F0C-281B-0EBF-F197-0B17170E1B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476F3-C897-446C-ACAC-3F861136C1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86471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48CD09-31AD-68F1-40F4-A7D4778344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75F0426-074F-A0A4-8EBD-F76E8CFCD5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6DEAEE1-7536-3A12-6331-20A98ED188B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468B933-EEDB-38F3-D374-D0A9E7ECDDB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AF98F0A-1673-EE3D-B14C-4385488731B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8985DC5-658A-6EC7-816C-1572FB5A2B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D68523-EE51-4EEB-BD16-FCB29625D885}" type="datetimeFigureOut">
              <a:rPr lang="en-US" smtClean="0"/>
              <a:t>1/27/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C0D5E2D-5E8A-109F-F01C-81AC7A6DF2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72BC108-868B-9BFD-A4F9-19E1582B9B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476F3-C897-446C-ACAC-3F861136C1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19950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4A737D-296F-5884-9D0B-501C2CA78B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89AAF8E-2BEA-9C68-4A62-D4C6D3F04D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D68523-EE51-4EEB-BD16-FCB29625D885}" type="datetimeFigureOut">
              <a:rPr lang="en-US" smtClean="0"/>
              <a:t>1/27/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2E8254A-7F1F-89F0-87A0-B4709A389A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50D4B33-D70E-0313-22A6-1D9014FBBC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476F3-C897-446C-ACAC-3F861136C1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1110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ADB01EF-2FC1-70B7-35EA-6AE8672413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D68523-EE51-4EEB-BD16-FCB29625D885}" type="datetimeFigureOut">
              <a:rPr lang="en-US" smtClean="0"/>
              <a:t>1/27/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2F986D9-D2B7-A4FF-016F-FA89E8A3C0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EE7ED88-59C5-6F7B-479F-7684226FC2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476F3-C897-446C-ACAC-3F861136C1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27191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8BAFB4-5262-B686-F751-BEFB54A142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54AF6BF-2076-4FAA-B2C0-1B76A34F818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173C74E-4C3F-D88A-EAA8-38086186016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2672493-9C36-9905-4434-8B06EDC05E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D68523-EE51-4EEB-BD16-FCB29625D885}" type="datetimeFigureOut">
              <a:rPr lang="en-US" smtClean="0"/>
              <a:t>1/27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D7A1F62-1AEC-EDFA-BBFE-3142E79E05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D14E700-47DC-9F55-3F5B-FF5B7BA799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476F3-C897-446C-ACAC-3F861136C1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47042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CAC4FB-C576-04F6-914D-88B2BED578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2330F98-77C4-BA79-C35B-A4B40921BA4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96CBA67-8730-FDDC-19FE-FC5ED9265B0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B6E5E0B-9DFD-FB35-72CC-D73A9E0F3D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D68523-EE51-4EEB-BD16-FCB29625D885}" type="datetimeFigureOut">
              <a:rPr lang="en-US" smtClean="0"/>
              <a:t>1/27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EC61169-F13C-E848-073C-0B475D10CC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DB1FFF6-A8B7-CDA4-D8FF-88D46E52E8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476F3-C897-446C-ACAC-3F861136C1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51256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E0F2214-60B2-E973-6BF5-67E080F8B3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CB19F31-D495-7BA1-3D92-D18A98150C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A9BF4D-7A38-CDDE-86B2-0D71D40CA8D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FD68523-EE51-4EEB-BD16-FCB29625D885}" type="datetimeFigureOut">
              <a:rPr lang="en-US" smtClean="0"/>
              <a:t>1/27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D4FBF7-B2B8-14B5-ACC2-67467865ABE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A393DC-F9E5-997C-52B9-798E7F779C4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16476F3-C897-446C-ACAC-3F861136C1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23118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jp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A49278F-CADC-6F17-4623-D6140970908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F116DC2F-3A69-4E2B-0883-8557088FA3B1}"/>
              </a:ext>
            </a:extLst>
          </p:cNvPr>
          <p:cNvSpPr txBox="1"/>
          <p:nvPr/>
        </p:nvSpPr>
        <p:spPr>
          <a:xfrm>
            <a:off x="134512" y="586522"/>
            <a:ext cx="5436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n-QA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669F8D5-0C40-E24C-58AB-95C1CF26AB9F}"/>
              </a:ext>
            </a:extLst>
          </p:cNvPr>
          <p:cNvSpPr txBox="1"/>
          <p:nvPr/>
        </p:nvSpPr>
        <p:spPr>
          <a:xfrm>
            <a:off x="5978897" y="536453"/>
            <a:ext cx="5436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QA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QA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 descr="A graph showing a hazard function&#10;&#10;AI-generated content may be incorrect.">
            <a:extLst>
              <a:ext uri="{FF2B5EF4-FFF2-40B4-BE49-F238E27FC236}">
                <a16:creationId xmlns:a16="http://schemas.microsoft.com/office/drawing/2014/main" id="{691D33B1-87F8-9F7A-7747-ACD6923F769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105"/>
          <a:stretch>
            <a:fillRect/>
          </a:stretch>
        </p:blipFill>
        <p:spPr>
          <a:xfrm>
            <a:off x="-25434" y="1105072"/>
            <a:ext cx="6276167" cy="3885380"/>
          </a:xfrm>
          <a:prstGeom prst="rect">
            <a:avLst/>
          </a:prstGeom>
        </p:spPr>
      </p:pic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818DE1C3-59BA-067F-5419-9ACC76CCA00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51913710"/>
              </p:ext>
            </p:extLst>
          </p:nvPr>
        </p:nvGraphicFramePr>
        <p:xfrm>
          <a:off x="406348" y="5168676"/>
          <a:ext cx="5355975" cy="14935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71195">
                  <a:extLst>
                    <a:ext uri="{9D8B030D-6E8A-4147-A177-3AD203B41FA5}">
                      <a16:colId xmlns:a16="http://schemas.microsoft.com/office/drawing/2014/main" val="743213225"/>
                    </a:ext>
                  </a:extLst>
                </a:gridCol>
                <a:gridCol w="1071195">
                  <a:extLst>
                    <a:ext uri="{9D8B030D-6E8A-4147-A177-3AD203B41FA5}">
                      <a16:colId xmlns:a16="http://schemas.microsoft.com/office/drawing/2014/main" val="637991754"/>
                    </a:ext>
                  </a:extLst>
                </a:gridCol>
                <a:gridCol w="1071195">
                  <a:extLst>
                    <a:ext uri="{9D8B030D-6E8A-4147-A177-3AD203B41FA5}">
                      <a16:colId xmlns:a16="http://schemas.microsoft.com/office/drawing/2014/main" val="815899033"/>
                    </a:ext>
                  </a:extLst>
                </a:gridCol>
                <a:gridCol w="1071195">
                  <a:extLst>
                    <a:ext uri="{9D8B030D-6E8A-4147-A177-3AD203B41FA5}">
                      <a16:colId xmlns:a16="http://schemas.microsoft.com/office/drawing/2014/main" val="625340116"/>
                    </a:ext>
                  </a:extLst>
                </a:gridCol>
                <a:gridCol w="1071195">
                  <a:extLst>
                    <a:ext uri="{9D8B030D-6E8A-4147-A177-3AD203B41FA5}">
                      <a16:colId xmlns:a16="http://schemas.microsoft.com/office/drawing/2014/main" val="295640499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y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0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0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88597778"/>
                  </a:ext>
                </a:extLst>
              </a:tr>
              <a:tr h="128503">
                <a:tc gridSpan="5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umber at risk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ptos" panose="02110004020202020204"/>
                        <a:ea typeface="+mn-ea"/>
                        <a:cs typeface="+mn-cs"/>
                      </a:endParaRPr>
                    </a:p>
                  </a:txBody>
                  <a:tcPr>
                    <a:solidFill>
                      <a:srgbClr val="E7EAED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ptos" panose="02110004020202020204"/>
                        <a:ea typeface="+mn-ea"/>
                        <a:cs typeface="+mn-cs"/>
                      </a:endParaRPr>
                    </a:p>
                  </a:txBody>
                  <a:tcPr>
                    <a:solidFill>
                      <a:srgbClr val="E7EAED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ptos" panose="02110004020202020204"/>
                        <a:ea typeface="+mn-ea"/>
                        <a:cs typeface="+mn-cs"/>
                      </a:endParaRPr>
                    </a:p>
                  </a:txBody>
                  <a:tcPr>
                    <a:solidFill>
                      <a:srgbClr val="E7EAED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ptos" panose="02110004020202020204"/>
                        <a:ea typeface="+mn-ea"/>
                        <a:cs typeface="+mn-cs"/>
                      </a:endParaRPr>
                    </a:p>
                  </a:txBody>
                  <a:tcPr>
                    <a:solidFill>
                      <a:srgbClr val="E7EAE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65994641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rgbClr val="0070C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-Diabetes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,869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2324653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betes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0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57153832"/>
                  </a:ext>
                </a:extLst>
              </a:tr>
              <a:tr h="0">
                <a:tc gridSpan="5"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800" b="1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umulative  number of events</a:t>
                      </a:r>
                    </a:p>
                  </a:txBody>
                  <a:tcP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34866404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rgbClr val="0070C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-Diabetes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3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4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5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82207283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betes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87389823"/>
                  </a:ext>
                </a:extLst>
              </a:tr>
            </a:tbl>
          </a:graphicData>
        </a:graphic>
      </p:graphicFrame>
      <p:pic>
        <p:nvPicPr>
          <p:cNvPr id="10" name="Picture 9">
            <a:extLst>
              <a:ext uri="{FF2B5EF4-FFF2-40B4-BE49-F238E27FC236}">
                <a16:creationId xmlns:a16="http://schemas.microsoft.com/office/drawing/2014/main" id="{21E4DF91-6116-1F27-853D-039F1DE6E27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82916" y="3871930"/>
            <a:ext cx="1078110" cy="297428"/>
          </a:xfrm>
          <a:prstGeom prst="rect">
            <a:avLst/>
          </a:prstGeom>
          <a:ln w="6350">
            <a:solidFill>
              <a:srgbClr val="000000"/>
            </a:solidFill>
          </a:ln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38A2ACFA-4AE6-09E6-CAB3-825032F429DF}"/>
              </a:ext>
            </a:extLst>
          </p:cNvPr>
          <p:cNvSpPr txBox="1"/>
          <p:nvPr/>
        </p:nvSpPr>
        <p:spPr>
          <a:xfrm>
            <a:off x="3841268" y="2078491"/>
            <a:ext cx="128070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-rank=0.517</a:t>
            </a: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F78E11FC-4F95-8393-B403-C243F039A77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14193384"/>
              </p:ext>
            </p:extLst>
          </p:nvPr>
        </p:nvGraphicFramePr>
        <p:xfrm>
          <a:off x="6675172" y="5130876"/>
          <a:ext cx="5110480" cy="149826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22096">
                  <a:extLst>
                    <a:ext uri="{9D8B030D-6E8A-4147-A177-3AD203B41FA5}">
                      <a16:colId xmlns:a16="http://schemas.microsoft.com/office/drawing/2014/main" val="743213225"/>
                    </a:ext>
                  </a:extLst>
                </a:gridCol>
                <a:gridCol w="1022096">
                  <a:extLst>
                    <a:ext uri="{9D8B030D-6E8A-4147-A177-3AD203B41FA5}">
                      <a16:colId xmlns:a16="http://schemas.microsoft.com/office/drawing/2014/main" val="637991754"/>
                    </a:ext>
                  </a:extLst>
                </a:gridCol>
                <a:gridCol w="1022096">
                  <a:extLst>
                    <a:ext uri="{9D8B030D-6E8A-4147-A177-3AD203B41FA5}">
                      <a16:colId xmlns:a16="http://schemas.microsoft.com/office/drawing/2014/main" val="815899033"/>
                    </a:ext>
                  </a:extLst>
                </a:gridCol>
                <a:gridCol w="1022096">
                  <a:extLst>
                    <a:ext uri="{9D8B030D-6E8A-4147-A177-3AD203B41FA5}">
                      <a16:colId xmlns:a16="http://schemas.microsoft.com/office/drawing/2014/main" val="625340116"/>
                    </a:ext>
                  </a:extLst>
                </a:gridCol>
                <a:gridCol w="1022096">
                  <a:extLst>
                    <a:ext uri="{9D8B030D-6E8A-4147-A177-3AD203B41FA5}">
                      <a16:colId xmlns:a16="http://schemas.microsoft.com/office/drawing/2014/main" val="2956404992"/>
                    </a:ext>
                  </a:extLst>
                </a:gridCol>
              </a:tblGrid>
              <a:tr h="198185">
                <a:tc>
                  <a:txBody>
                    <a:bodyPr/>
                    <a:lstStyle/>
                    <a:p>
                      <a:r>
                        <a:rPr lang="en-US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0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0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88597778"/>
                  </a:ext>
                </a:extLst>
              </a:tr>
              <a:tr h="141843">
                <a:tc gridSpan="5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umber at risk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ptos" panose="02110004020202020204"/>
                        <a:ea typeface="+mn-ea"/>
                        <a:cs typeface="+mn-cs"/>
                      </a:endParaRPr>
                    </a:p>
                  </a:txBody>
                  <a:tcPr>
                    <a:solidFill>
                      <a:srgbClr val="E7EAED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ptos" panose="02110004020202020204"/>
                        <a:ea typeface="+mn-ea"/>
                        <a:cs typeface="+mn-cs"/>
                      </a:endParaRPr>
                    </a:p>
                  </a:txBody>
                  <a:tcPr>
                    <a:solidFill>
                      <a:srgbClr val="E7EAED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ptos" panose="02110004020202020204"/>
                        <a:ea typeface="+mn-ea"/>
                        <a:cs typeface="+mn-cs"/>
                      </a:endParaRPr>
                    </a:p>
                  </a:txBody>
                  <a:tcPr>
                    <a:solidFill>
                      <a:srgbClr val="E7EAED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ptos" panose="02110004020202020204"/>
                        <a:ea typeface="+mn-ea"/>
                        <a:cs typeface="+mn-cs"/>
                      </a:endParaRPr>
                    </a:p>
                  </a:txBody>
                  <a:tcPr>
                    <a:solidFill>
                      <a:srgbClr val="E7EAE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65994641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rgbClr val="0070C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-Diabetes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,874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8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6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2324653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abetes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0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57153832"/>
                  </a:ext>
                </a:extLst>
              </a:tr>
              <a:tr h="0">
                <a:tc gridSpan="5"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800" b="1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umulative  number of events</a:t>
                      </a:r>
                    </a:p>
                  </a:txBody>
                  <a:tcP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34866404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rgbClr val="0070C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-Diabetes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2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84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49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82207283"/>
                  </a:ext>
                </a:extLst>
              </a:tr>
              <a:tr h="218103"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abetes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7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5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6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87389823"/>
                  </a:ext>
                </a:extLst>
              </a:tr>
            </a:tbl>
          </a:graphicData>
        </a:graphic>
      </p:graphicFrame>
      <p:pic>
        <p:nvPicPr>
          <p:cNvPr id="7" name="Picture 6" descr="A graph showing the number of days between index and readmissing dates&#10;&#10;AI-generated content may be incorrect.">
            <a:extLst>
              <a:ext uri="{FF2B5EF4-FFF2-40B4-BE49-F238E27FC236}">
                <a16:creationId xmlns:a16="http://schemas.microsoft.com/office/drawing/2014/main" id="{55EBF36F-DF61-ECB4-1095-A01C5334B6A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077" r="14935" b="821"/>
          <a:stretch/>
        </p:blipFill>
        <p:spPr>
          <a:xfrm>
            <a:off x="5762323" y="1105072"/>
            <a:ext cx="6395093" cy="3937128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1A0A6141-4EDB-6943-0C13-E91AF1D298C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320028" y="3871930"/>
            <a:ext cx="1078110" cy="297428"/>
          </a:xfrm>
          <a:prstGeom prst="rect">
            <a:avLst/>
          </a:prstGeom>
          <a:ln w="6350">
            <a:solidFill>
              <a:srgbClr val="000000"/>
            </a:solidFill>
          </a:ln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6EF2F9AF-0545-C24C-8EF4-127385DFA80E}"/>
              </a:ext>
            </a:extLst>
          </p:cNvPr>
          <p:cNvSpPr txBox="1"/>
          <p:nvPr/>
        </p:nvSpPr>
        <p:spPr>
          <a:xfrm>
            <a:off x="10120369" y="2078491"/>
            <a:ext cx="147742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-rank p= 0.125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2CA18A1-B3EE-B95A-D18D-FA287F339E21}"/>
              </a:ext>
            </a:extLst>
          </p:cNvPr>
          <p:cNvSpPr txBox="1"/>
          <p:nvPr/>
        </p:nvSpPr>
        <p:spPr>
          <a:xfrm>
            <a:off x="121605" y="67973"/>
            <a:ext cx="1206412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S1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Kaplan-Meier curves for 1-year (a) mortality and (b) readmission in patients with myocarditis.</a:t>
            </a:r>
            <a:endParaRPr lang="en-QA" dirty="0"/>
          </a:p>
        </p:txBody>
      </p:sp>
    </p:spTree>
    <p:extLst>
      <p:ext uri="{BB962C8B-B14F-4D97-AF65-F5344CB8AC3E}">
        <p14:creationId xmlns:p14="http://schemas.microsoft.com/office/powerpoint/2010/main" val="32440947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573f5887-035d-4765-8d10-97aaac8deb4a}" enabled="1" method="Standard" siteId="{f08ae827-76a0-4eda-8325-df208f3835ab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973</TotalTime>
  <Words>99</Words>
  <Application>Microsoft Macintosh PowerPoint</Application>
  <PresentationFormat>Widescreen</PresentationFormat>
  <Paragraphs>6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ayane El-Khoury</dc:creator>
  <cp:lastModifiedBy>Charbel Abi Khalil</cp:lastModifiedBy>
  <cp:revision>87</cp:revision>
  <dcterms:created xsi:type="dcterms:W3CDTF">2025-03-05T09:40:43Z</dcterms:created>
  <dcterms:modified xsi:type="dcterms:W3CDTF">2026-01-27T16:33:21Z</dcterms:modified>
</cp:coreProperties>
</file>